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502" r:id="rId2"/>
  </p:sldIdLst>
  <p:sldSz cx="12192000" cy="9144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28698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173" autoAdjust="0"/>
    <p:restoredTop sz="89280" autoAdjust="0"/>
  </p:normalViewPr>
  <p:slideViewPr>
    <p:cSldViewPr snapToGrid="0">
      <p:cViewPr varScale="1">
        <p:scale>
          <a:sx n="73" d="100"/>
          <a:sy n="73" d="100"/>
        </p:scale>
        <p:origin x="2190" y="72"/>
      </p:cViewPr>
      <p:guideLst/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F28B7A6-A418-4C37-8DE7-370EEF89986F}" type="datetimeFigureOut">
              <a:rPr lang="en-US" smtClean="0"/>
              <a:t>10/25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1F0C8CD-7C34-44D0-AB1A-3784C53859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022085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371600" y="1143000"/>
            <a:ext cx="41148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algn="just">
              <a:lnSpc>
                <a:spcPct val="107000"/>
              </a:lnSpc>
              <a:spcAft>
                <a:spcPts val="800"/>
              </a:spcAft>
            </a:pPr>
            <a:r>
              <a:rPr lang="en-US" sz="1800" b="1" kern="10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Fig. S6</a:t>
            </a:r>
            <a:r>
              <a:rPr lang="en-US" sz="1800" b="1" kern="10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: PBMC subtype frequencies in idiopathic PD, </a:t>
            </a:r>
            <a:r>
              <a:rPr lang="en-US" sz="1800" b="1" i="1" kern="10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LRRK2-</a:t>
            </a:r>
            <a:r>
              <a:rPr lang="en-US" sz="1800" b="1" kern="10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PD, and </a:t>
            </a:r>
            <a:r>
              <a:rPr lang="en-US" sz="1800" b="1" i="1" kern="10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GBA1</a:t>
            </a:r>
            <a:r>
              <a:rPr lang="en-US" sz="1800" b="1" kern="10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-</a:t>
            </a:r>
            <a:r>
              <a:rPr lang="en-US" sz="1800" b="1" kern="10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PD</a:t>
            </a:r>
            <a:r>
              <a:rPr lang="en-US" sz="1800" b="0" kern="10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. Bar graphs overlaid with scatter plots showing frequency of PBMC subtypes after </a:t>
            </a:r>
            <a:r>
              <a:rPr lang="en-US" sz="1800" b="0" i="1" kern="10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P. aeruginosa</a:t>
            </a:r>
            <a:r>
              <a:rPr lang="en-US" sz="1800" b="0" kern="10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treatment for NHCs, iPD patients, </a:t>
            </a:r>
            <a:r>
              <a:rPr lang="en-US" sz="1800" b="0" i="1" kern="10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LRRK2-PD</a:t>
            </a:r>
            <a:r>
              <a:rPr lang="en-US" sz="1800" b="0" kern="10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patients, and </a:t>
            </a:r>
            <a:r>
              <a:rPr lang="en-US" sz="1800" b="0" i="1" kern="10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GBA-</a:t>
            </a:r>
            <a:r>
              <a:rPr lang="en-US" sz="1800" b="0" kern="10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PD patients. (</a:t>
            </a:r>
            <a:r>
              <a:rPr lang="en-US" sz="1800" b="1" kern="10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A</a:t>
            </a:r>
            <a:r>
              <a:rPr lang="en-US" sz="1800" b="0" kern="10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) Frequency of CD3+ T cells (Effect of Interaction </a:t>
            </a:r>
            <a:r>
              <a:rPr lang="en-US" sz="1800" b="0" i="1" kern="10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p</a:t>
            </a:r>
            <a:r>
              <a:rPr lang="en-US" sz="1800" b="0" kern="10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= 0.8731, Treatment </a:t>
            </a:r>
            <a:r>
              <a:rPr lang="en-US" sz="1800" b="0" i="1" kern="10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p</a:t>
            </a:r>
            <a:r>
              <a:rPr lang="en-US" sz="1800" b="0" kern="10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= 0.5280, Cohort </a:t>
            </a:r>
            <a:r>
              <a:rPr lang="en-US" sz="1800" b="0" i="1" kern="10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p </a:t>
            </a:r>
            <a:r>
              <a:rPr lang="en-US" sz="1800" b="0" kern="10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= 0.8475). (</a:t>
            </a:r>
            <a:r>
              <a:rPr lang="en-US" sz="1800" b="1" kern="10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B</a:t>
            </a:r>
            <a:r>
              <a:rPr lang="en-US" sz="1800" b="0" kern="10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) Frequency of classical monocytes (Effect of Interaction </a:t>
            </a:r>
            <a:r>
              <a:rPr lang="en-US" sz="1800" b="0" i="1" kern="10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p</a:t>
            </a:r>
            <a:r>
              <a:rPr lang="en-US" sz="1800" b="0" kern="10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= 0.9989, Treatment </a:t>
            </a:r>
            <a:r>
              <a:rPr lang="en-US" sz="1800" b="0" i="1" kern="10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p</a:t>
            </a:r>
            <a:r>
              <a:rPr lang="en-US" sz="1800" b="0" kern="10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= 0.2048, Cohort </a:t>
            </a:r>
            <a:r>
              <a:rPr lang="en-US" sz="1800" b="0" i="1" kern="10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p </a:t>
            </a:r>
            <a:r>
              <a:rPr lang="en-US" sz="1800" b="0" kern="10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= 0.1156). (</a:t>
            </a:r>
            <a:r>
              <a:rPr lang="en-US" sz="1800" b="1" kern="10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C</a:t>
            </a:r>
            <a:r>
              <a:rPr lang="en-US" sz="1800" b="0" kern="10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) Frequency of intermediate monocytes (Effect of Interaction </a:t>
            </a:r>
            <a:r>
              <a:rPr lang="en-US" sz="1800" b="0" i="1" kern="10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p</a:t>
            </a:r>
            <a:r>
              <a:rPr lang="en-US" sz="1800" b="0" kern="10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= 0.9730, Treatment </a:t>
            </a:r>
            <a:r>
              <a:rPr lang="en-US" sz="1800" b="0" i="1" kern="10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p</a:t>
            </a:r>
            <a:r>
              <a:rPr lang="en-US" sz="1800" b="0" kern="10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= 0.5536, Cohort </a:t>
            </a:r>
            <a:r>
              <a:rPr lang="en-US" sz="1800" b="0" i="1" kern="10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p </a:t>
            </a:r>
            <a:r>
              <a:rPr lang="en-US" sz="1800" b="0" kern="10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= 0.2865). (</a:t>
            </a:r>
            <a:r>
              <a:rPr lang="en-US" sz="1800" b="1" kern="10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D</a:t>
            </a:r>
            <a:r>
              <a:rPr lang="en-US" sz="1800" b="0" kern="10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) Frequency of nonclassical monocytes (Effect of Interaction </a:t>
            </a:r>
            <a:r>
              <a:rPr lang="en-US" sz="1800" b="0" i="1" kern="10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p</a:t>
            </a:r>
            <a:r>
              <a:rPr lang="en-US" sz="1800" b="0" kern="10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= 0.9554, Treatment </a:t>
            </a:r>
            <a:r>
              <a:rPr lang="en-US" sz="1800" b="0" i="1" kern="10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p</a:t>
            </a:r>
            <a:r>
              <a:rPr lang="en-US" sz="1800" b="0" kern="10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= 0.6990, Cohort </a:t>
            </a:r>
            <a:r>
              <a:rPr lang="en-US" sz="1800" b="0" i="1" kern="10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p </a:t>
            </a:r>
            <a:r>
              <a:rPr lang="en-US" sz="1800" b="0" kern="10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= 0.0007). (</a:t>
            </a:r>
            <a:r>
              <a:rPr lang="en-US" sz="1800" b="1" kern="10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E</a:t>
            </a:r>
            <a:r>
              <a:rPr lang="en-US" sz="1800" b="0" kern="10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) Frequency of CD3-/CD14-/CD16- cells (Effect of Interaction </a:t>
            </a:r>
            <a:r>
              <a:rPr lang="en-US" sz="1800" b="0" i="1" kern="10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p</a:t>
            </a:r>
            <a:r>
              <a:rPr lang="en-US" sz="1800" b="0" kern="10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= 0.8629, Treatment </a:t>
            </a:r>
            <a:r>
              <a:rPr lang="en-US" sz="1800" b="0" i="1" kern="10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p</a:t>
            </a:r>
            <a:r>
              <a:rPr lang="en-US" sz="1800" b="0" kern="10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= 0.2376, Cohort </a:t>
            </a:r>
            <a:r>
              <a:rPr lang="en-US" sz="1800" b="0" i="1" kern="10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p </a:t>
            </a:r>
            <a:r>
              <a:rPr lang="en-US" sz="1800" b="0" kern="10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= 0.0043). Bars represent mean +/- SEM. NHCs, </a:t>
            </a:r>
            <a:r>
              <a:rPr lang="en-US" sz="1800" b="0" i="1" kern="10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n </a:t>
            </a:r>
            <a:r>
              <a:rPr lang="en-US" sz="1800" b="0" kern="10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= 24; iPD, </a:t>
            </a:r>
            <a:r>
              <a:rPr lang="en-US" sz="1800" b="0" i="1" kern="10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n</a:t>
            </a:r>
            <a:r>
              <a:rPr lang="en-US" sz="1800" b="0" kern="10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= 33; </a:t>
            </a:r>
            <a:r>
              <a:rPr lang="en-US" sz="1800" b="0" i="1" kern="10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LRRK2-PD</a:t>
            </a:r>
            <a:r>
              <a:rPr lang="en-US" sz="1800" b="0" kern="10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, </a:t>
            </a:r>
            <a:r>
              <a:rPr lang="en-US" sz="1800" b="0" i="1" kern="10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n</a:t>
            </a:r>
            <a:r>
              <a:rPr lang="en-US" sz="1800" b="0" kern="10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= 21; </a:t>
            </a:r>
            <a:r>
              <a:rPr lang="en-US" sz="1800" b="0" i="1" kern="10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GBA-</a:t>
            </a:r>
            <a:r>
              <a:rPr lang="en-US" sz="1800" b="0" kern="10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PD, </a:t>
            </a:r>
            <a:r>
              <a:rPr lang="en-US" sz="1800" b="0" i="1" kern="10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n</a:t>
            </a:r>
            <a:r>
              <a:rPr lang="en-US" sz="1800" b="0" kern="10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= 17. Each symbol represents the measurement from a single individual. The results in A-E were analyzed using two-way ANOVA with Tukey’s corrections for multiple comparisons. Only comparisons within treatment and comparisons within cohorts across treatment are shown. Statistically significant differences defined by </a:t>
            </a:r>
            <a:r>
              <a:rPr lang="en-US" sz="1800" b="0" i="1" kern="10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p </a:t>
            </a:r>
            <a:r>
              <a:rPr lang="en-US" sz="1800" b="0" kern="10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&lt; 0.05 are shown</a:t>
            </a:r>
            <a:r>
              <a:rPr lang="en-US" sz="1800" b="0" i="1" kern="10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.</a:t>
            </a:r>
            <a:r>
              <a:rPr lang="en-US" sz="1800" b="0" kern="10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</a:t>
            </a:r>
            <a:endParaRPr lang="en-US" sz="1800" b="0" kern="100" dirty="0">
              <a:effectLst/>
              <a:latin typeface="Arial" panose="020B06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1F0C8CD-7C34-44D0-AB1A-3784C5385934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349294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1496484"/>
            <a:ext cx="10363200" cy="3183467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4802717"/>
            <a:ext cx="9144000" cy="2207683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C8883-C0BB-4EFA-870D-8ECEB2739B33}" type="datetimeFigureOut">
              <a:rPr lang="en-US" smtClean="0"/>
              <a:t>10/2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A08E50-E2B4-48E1-A8DB-3F0C8B8600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18789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C8883-C0BB-4EFA-870D-8ECEB2739B33}" type="datetimeFigureOut">
              <a:rPr lang="en-US" smtClean="0"/>
              <a:t>10/2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A08E50-E2B4-48E1-A8DB-3F0C8B8600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03859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486834"/>
            <a:ext cx="2628900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486834"/>
            <a:ext cx="7734300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C8883-C0BB-4EFA-870D-8ECEB2739B33}" type="datetimeFigureOut">
              <a:rPr lang="en-US" smtClean="0"/>
              <a:t>10/2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A08E50-E2B4-48E1-A8DB-3F0C8B8600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79865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C8883-C0BB-4EFA-870D-8ECEB2739B33}" type="datetimeFigureOut">
              <a:rPr lang="en-US" smtClean="0"/>
              <a:t>10/2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A08E50-E2B4-48E1-A8DB-3F0C8B8600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5119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2279653"/>
            <a:ext cx="10515600" cy="3803649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6119286"/>
            <a:ext cx="10515600" cy="200024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>
                    <a:tint val="82000"/>
                  </a:schemeClr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82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82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82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82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82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82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C8883-C0BB-4EFA-870D-8ECEB2739B33}" type="datetimeFigureOut">
              <a:rPr lang="en-US" smtClean="0"/>
              <a:t>10/2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A08E50-E2B4-48E1-A8DB-3F0C8B8600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52605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2434167"/>
            <a:ext cx="518160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2434167"/>
            <a:ext cx="518160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C8883-C0BB-4EFA-870D-8ECEB2739B33}" type="datetimeFigureOut">
              <a:rPr lang="en-US" smtClean="0"/>
              <a:t>10/25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A08E50-E2B4-48E1-A8DB-3F0C8B8600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51960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86836"/>
            <a:ext cx="10515600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2241551"/>
            <a:ext cx="5157787" cy="1098549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3340100"/>
            <a:ext cx="5157787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2241551"/>
            <a:ext cx="5183188" cy="1098549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3340100"/>
            <a:ext cx="5183188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C8883-C0BB-4EFA-870D-8ECEB2739B33}" type="datetimeFigureOut">
              <a:rPr lang="en-US" smtClean="0"/>
              <a:t>10/25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A08E50-E2B4-48E1-A8DB-3F0C8B8600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5141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C8883-C0BB-4EFA-870D-8ECEB2739B33}" type="datetimeFigureOut">
              <a:rPr lang="en-US" smtClean="0"/>
              <a:t>10/25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A08E50-E2B4-48E1-A8DB-3F0C8B8600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437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C8883-C0BB-4EFA-870D-8ECEB2739B33}" type="datetimeFigureOut">
              <a:rPr lang="en-US" smtClean="0"/>
              <a:t>10/25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A08E50-E2B4-48E1-A8DB-3F0C8B8600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20777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609600"/>
            <a:ext cx="3932237" cy="213360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1316569"/>
            <a:ext cx="6172200" cy="6498167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743200"/>
            <a:ext cx="3932237" cy="5082117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C8883-C0BB-4EFA-870D-8ECEB2739B33}" type="datetimeFigureOut">
              <a:rPr lang="en-US" smtClean="0"/>
              <a:t>10/25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A08E50-E2B4-48E1-A8DB-3F0C8B8600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98131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609600"/>
            <a:ext cx="3932237" cy="213360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1316569"/>
            <a:ext cx="6172200" cy="6498167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743200"/>
            <a:ext cx="3932237" cy="5082117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C8883-C0BB-4EFA-870D-8ECEB2739B33}" type="datetimeFigureOut">
              <a:rPr lang="en-US" smtClean="0"/>
              <a:t>10/25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A08E50-E2B4-48E1-A8DB-3F0C8B8600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11749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486836"/>
            <a:ext cx="10515600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2434167"/>
            <a:ext cx="10515600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8475136"/>
            <a:ext cx="2743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B8C8883-C0BB-4EFA-870D-8ECEB2739B33}" type="datetimeFigureOut">
              <a:rPr lang="en-US" smtClean="0"/>
              <a:t>10/2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8475136"/>
            <a:ext cx="41148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8475136"/>
            <a:ext cx="2743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8A08E50-E2B4-48E1-A8DB-3F0C8B8600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59441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emf"/><Relationship Id="rId7" Type="http://schemas.openxmlformats.org/officeDocument/2006/relationships/image" Target="../media/image5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emf"/><Relationship Id="rId5" Type="http://schemas.openxmlformats.org/officeDocument/2006/relationships/image" Target="../media/image3.emf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BA794578-BF83-A52B-02DF-EF6925412BE5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" name="Picture 13">
            <a:extLst>
              <a:ext uri="{FF2B5EF4-FFF2-40B4-BE49-F238E27FC236}">
                <a16:creationId xmlns:a16="http://schemas.microsoft.com/office/drawing/2014/main" id="{C9E20354-16D3-8AE3-3845-D5F264C86A3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303744" y="3558135"/>
            <a:ext cx="3061934" cy="2926080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C483DA05-85E0-3B5A-40C6-E0FD00DB047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244408" y="3552729"/>
            <a:ext cx="3040730" cy="2926080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FB4BCF0D-8CE0-DB3D-BC89-795F38AC5680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08468" y="3557191"/>
            <a:ext cx="3124635" cy="2926080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317212A3-3591-D383-43BD-B990C478C2E9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278100" y="550507"/>
            <a:ext cx="3124635" cy="2926080"/>
          </a:xfrm>
          <a:prstGeom prst="rect">
            <a:avLst/>
          </a:prstGeom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6B9F915C-79EA-597A-5D44-F9DCDDABEE93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17942" y="546248"/>
            <a:ext cx="3187337" cy="2926080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F487249B-F349-F55B-0B3E-B8B20646612B}"/>
              </a:ext>
            </a:extLst>
          </p:cNvPr>
          <p:cNvSpPr txBox="1"/>
          <p:nvPr/>
        </p:nvSpPr>
        <p:spPr>
          <a:xfrm>
            <a:off x="218741" y="555059"/>
            <a:ext cx="3432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6EA4AA59-18CD-A9B5-FFF6-D2AB47973A46}"/>
              </a:ext>
            </a:extLst>
          </p:cNvPr>
          <p:cNvSpPr txBox="1"/>
          <p:nvPr/>
        </p:nvSpPr>
        <p:spPr>
          <a:xfrm>
            <a:off x="3277322" y="556384"/>
            <a:ext cx="3432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68452AA6-0B2E-1829-F2F3-885E8A627789}"/>
              </a:ext>
            </a:extLst>
          </p:cNvPr>
          <p:cNvSpPr txBox="1"/>
          <p:nvPr/>
        </p:nvSpPr>
        <p:spPr>
          <a:xfrm>
            <a:off x="213890" y="3556755"/>
            <a:ext cx="3432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B0799200-CB90-CE27-A235-88A4ABC0F9E1}"/>
              </a:ext>
            </a:extLst>
          </p:cNvPr>
          <p:cNvSpPr txBox="1"/>
          <p:nvPr/>
        </p:nvSpPr>
        <p:spPr>
          <a:xfrm>
            <a:off x="3278650" y="3557414"/>
            <a:ext cx="3432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8FD60E67-242F-EF3B-9392-EE17CF5B3CB2}"/>
              </a:ext>
            </a:extLst>
          </p:cNvPr>
          <p:cNvSpPr txBox="1"/>
          <p:nvPr/>
        </p:nvSpPr>
        <p:spPr>
          <a:xfrm>
            <a:off x="6218695" y="3551650"/>
            <a:ext cx="3432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A880AB1D-0312-8991-D4B7-AF15E199D153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7139970" y="1277204"/>
            <a:ext cx="1459382" cy="1280160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9F12BD1F-CE59-370E-F4B7-6AA829A3E827}"/>
              </a:ext>
            </a:extLst>
          </p:cNvPr>
          <p:cNvSpPr txBox="1"/>
          <p:nvPr/>
        </p:nvSpPr>
        <p:spPr>
          <a:xfrm>
            <a:off x="0" y="0"/>
            <a:ext cx="826712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/>
              <a:t>Fig. S6</a:t>
            </a:r>
            <a:endParaRPr lang="en-US" sz="2400" b="1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B16D4ED6-8C74-B51B-521C-712706E74E3B}"/>
              </a:ext>
            </a:extLst>
          </p:cNvPr>
          <p:cNvSpPr txBox="1"/>
          <p:nvPr/>
        </p:nvSpPr>
        <p:spPr>
          <a:xfrm>
            <a:off x="55421" y="6519684"/>
            <a:ext cx="9045035" cy="20542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algn="just">
              <a:lnSpc>
                <a:spcPct val="107000"/>
              </a:lnSpc>
              <a:spcAft>
                <a:spcPts val="800"/>
              </a:spcAft>
            </a:pPr>
            <a:r>
              <a:rPr lang="en-US" sz="1200" b="1" kern="100" dirty="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Fig</a:t>
            </a:r>
            <a:r>
              <a:rPr lang="en-US" sz="1200" b="1" kern="10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. S6</a:t>
            </a:r>
            <a:r>
              <a:rPr lang="en-US" sz="1200" b="1" kern="10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: </a:t>
            </a:r>
            <a:r>
              <a:rPr lang="en-US" sz="1200" b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PBMC subtype frequencies </a:t>
            </a:r>
            <a:r>
              <a:rPr lang="en-US" sz="1200" b="1" kern="10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in idiopathic PD, </a:t>
            </a:r>
            <a:r>
              <a:rPr lang="en-US" sz="1200" b="1" i="1" kern="10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LRRK2-</a:t>
            </a:r>
            <a:r>
              <a:rPr lang="en-US" sz="1200" b="1" kern="10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PD, and </a:t>
            </a:r>
            <a:r>
              <a:rPr lang="en-US" sz="1200" b="1" i="1" kern="10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GBA1</a:t>
            </a:r>
            <a:r>
              <a:rPr lang="en-US" sz="1200" b="1" kern="10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-</a:t>
            </a:r>
            <a:r>
              <a:rPr lang="en-US" sz="1200" b="1" kern="10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PD</a:t>
            </a:r>
            <a:r>
              <a:rPr lang="en-US" sz="1200" b="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. Bar graphs overlaid with scatter plots showing frequency of PBMC subtypes after </a:t>
            </a:r>
            <a:r>
              <a:rPr lang="en-US" sz="1200" b="0" i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P. aeruginosa</a:t>
            </a:r>
            <a:r>
              <a:rPr lang="en-US" sz="1200" b="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treatment for NHCs, </a:t>
            </a:r>
            <a:r>
              <a:rPr lang="en-US" sz="1200" b="0" kern="100" dirty="0" err="1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iPD</a:t>
            </a:r>
            <a:r>
              <a:rPr lang="en-US" sz="1200" b="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patients, </a:t>
            </a:r>
            <a:r>
              <a:rPr lang="en-US" sz="1200" b="0" i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LRRK2-PD</a:t>
            </a:r>
            <a:r>
              <a:rPr lang="en-US" sz="1200" b="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patients, and </a:t>
            </a:r>
            <a:r>
              <a:rPr lang="en-US" sz="1200" b="0" i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GBA-</a:t>
            </a:r>
            <a:r>
              <a:rPr lang="en-US" sz="1200" b="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PD patients. (</a:t>
            </a:r>
            <a:r>
              <a:rPr lang="en-US" sz="1200" b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A</a:t>
            </a:r>
            <a:r>
              <a:rPr lang="en-US" sz="1200" b="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) Frequency of CD3+ T cells (Effect of Interaction </a:t>
            </a:r>
            <a:r>
              <a:rPr lang="en-US" sz="1200" b="0" i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p</a:t>
            </a:r>
            <a:r>
              <a:rPr lang="en-US" sz="1200" b="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= 0.8731, Treatment </a:t>
            </a:r>
            <a:r>
              <a:rPr lang="en-US" sz="1200" b="0" i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p</a:t>
            </a:r>
            <a:r>
              <a:rPr lang="en-US" sz="1200" b="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= 0.5280, Cohort </a:t>
            </a:r>
            <a:r>
              <a:rPr lang="en-US" sz="1200" b="0" i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p </a:t>
            </a:r>
            <a:r>
              <a:rPr lang="en-US" sz="1200" b="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= 0.8475). (</a:t>
            </a:r>
            <a:r>
              <a:rPr lang="en-US" sz="1200" b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B</a:t>
            </a:r>
            <a:r>
              <a:rPr lang="en-US" sz="1200" b="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) Frequency of classical monocytes (Effect of Interaction </a:t>
            </a:r>
            <a:r>
              <a:rPr lang="en-US" sz="1200" b="0" i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p</a:t>
            </a:r>
            <a:r>
              <a:rPr lang="en-US" sz="1200" b="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= 0.9989, Treatment </a:t>
            </a:r>
            <a:r>
              <a:rPr lang="en-US" sz="1200" b="0" i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p</a:t>
            </a:r>
            <a:r>
              <a:rPr lang="en-US" sz="1200" b="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= 0.2048, Cohort </a:t>
            </a:r>
            <a:r>
              <a:rPr lang="en-US" sz="1200" b="0" i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p </a:t>
            </a:r>
            <a:r>
              <a:rPr lang="en-US" sz="1200" b="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= 0.1156). (</a:t>
            </a:r>
            <a:r>
              <a:rPr lang="en-US" sz="1200" b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C</a:t>
            </a:r>
            <a:r>
              <a:rPr lang="en-US" sz="1200" b="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) Frequency of intermediate monocytes (Effect of Interaction </a:t>
            </a:r>
            <a:r>
              <a:rPr lang="en-US" sz="1200" b="0" i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p</a:t>
            </a:r>
            <a:r>
              <a:rPr lang="en-US" sz="1200" b="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= 0.9730, Treatment </a:t>
            </a:r>
            <a:r>
              <a:rPr lang="en-US" sz="1200" b="0" i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p</a:t>
            </a:r>
            <a:r>
              <a:rPr lang="en-US" sz="1200" b="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= 0.5536, Cohort </a:t>
            </a:r>
            <a:r>
              <a:rPr lang="en-US" sz="1200" b="0" i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p </a:t>
            </a:r>
            <a:r>
              <a:rPr lang="en-US" sz="1200" b="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= 0.2865). (</a:t>
            </a:r>
            <a:r>
              <a:rPr lang="en-US" sz="1200" b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D</a:t>
            </a:r>
            <a:r>
              <a:rPr lang="en-US" sz="1200" b="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) Frequency of nonclassical monocytes (Effect of Interaction </a:t>
            </a:r>
            <a:r>
              <a:rPr lang="en-US" sz="1200" b="0" i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p</a:t>
            </a:r>
            <a:r>
              <a:rPr lang="en-US" sz="1200" b="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= 0.9554, Treatment </a:t>
            </a:r>
            <a:r>
              <a:rPr lang="en-US" sz="1200" b="0" i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p</a:t>
            </a:r>
            <a:r>
              <a:rPr lang="en-US" sz="1200" b="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= 0.6990, Cohort </a:t>
            </a:r>
            <a:r>
              <a:rPr lang="en-US" sz="1200" b="0" i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p </a:t>
            </a:r>
            <a:r>
              <a:rPr lang="en-US" sz="1200" b="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= 0.0007). (</a:t>
            </a:r>
            <a:r>
              <a:rPr lang="en-US" sz="1200" b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E</a:t>
            </a:r>
            <a:r>
              <a:rPr lang="en-US" sz="1200" b="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) Frequency of CD3-/CD14-/CD16- cells (Effect of Interaction </a:t>
            </a:r>
            <a:r>
              <a:rPr lang="en-US" sz="1200" b="0" i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p</a:t>
            </a:r>
            <a:r>
              <a:rPr lang="en-US" sz="1200" b="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= 0.8629, Treatment </a:t>
            </a:r>
            <a:r>
              <a:rPr lang="en-US" sz="1200" b="0" i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p</a:t>
            </a:r>
            <a:r>
              <a:rPr lang="en-US" sz="1200" b="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= 0.2376, Cohort </a:t>
            </a:r>
            <a:r>
              <a:rPr lang="en-US" sz="1200" b="0" i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p </a:t>
            </a:r>
            <a:r>
              <a:rPr lang="en-US" sz="1200" b="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= 0.0043). Bars represent mean +/- SEM. NHCs, </a:t>
            </a:r>
            <a:r>
              <a:rPr lang="en-US" sz="1200" b="0" i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n </a:t>
            </a:r>
            <a:r>
              <a:rPr lang="en-US" sz="1200" b="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= 24; </a:t>
            </a:r>
            <a:r>
              <a:rPr lang="en-US" sz="1200" b="0" kern="100" dirty="0" err="1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iPD</a:t>
            </a:r>
            <a:r>
              <a:rPr lang="en-US" sz="1200" b="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, </a:t>
            </a:r>
            <a:r>
              <a:rPr lang="en-US" sz="1200" b="0" i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n</a:t>
            </a:r>
            <a:r>
              <a:rPr lang="en-US" sz="1200" b="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= 33; </a:t>
            </a:r>
            <a:r>
              <a:rPr lang="en-US" sz="1200" b="0" i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LRRK2-PD</a:t>
            </a:r>
            <a:r>
              <a:rPr lang="en-US" sz="1200" b="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, </a:t>
            </a:r>
            <a:r>
              <a:rPr lang="en-US" sz="1200" b="0" i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n</a:t>
            </a:r>
            <a:r>
              <a:rPr lang="en-US" sz="1200" b="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= 21; </a:t>
            </a:r>
            <a:r>
              <a:rPr lang="en-US" sz="1200" b="0" i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GBA-</a:t>
            </a:r>
            <a:r>
              <a:rPr lang="en-US" sz="1200" b="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PD, </a:t>
            </a:r>
            <a:r>
              <a:rPr lang="en-US" sz="1200" b="0" i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n</a:t>
            </a:r>
            <a:r>
              <a:rPr lang="en-US" sz="1200" b="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= 17. Each symbol represents the measurement from a single individual. The results in A-E were analyzed using two-way ANOVA with Tukey’s corrections for multiple comparisons. Only comparisons within treatment and comparisons within cohorts across treatment are shown. Statistically significant differences defined by </a:t>
            </a:r>
            <a:r>
              <a:rPr lang="en-US" sz="1200" b="0" i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p </a:t>
            </a:r>
            <a:r>
              <a:rPr lang="en-US" sz="1200" b="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&lt; 0.05 are shown</a:t>
            </a:r>
            <a:r>
              <a:rPr lang="en-US" sz="1200" b="0" i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.</a:t>
            </a:r>
            <a:r>
              <a:rPr lang="en-US" sz="1200" b="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63596191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945</TotalTime>
  <Words>521</Words>
  <Application>Microsoft Office PowerPoint</Application>
  <PresentationFormat>Custom</PresentationFormat>
  <Paragraphs>9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LRRK2/GBA1 mutations peripheral immune cells in Parkinson’s disease</dc:title>
  <dc:creator>Julian Mark</dc:creator>
  <cp:lastModifiedBy>Mark, Julian</cp:lastModifiedBy>
  <cp:revision>810</cp:revision>
  <dcterms:created xsi:type="dcterms:W3CDTF">2025-01-19T15:31:25Z</dcterms:created>
  <dcterms:modified xsi:type="dcterms:W3CDTF">2025-10-25T20:12:27Z</dcterms:modified>
</cp:coreProperties>
</file>